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1" r:id="rId2"/>
  </p:sldIdLst>
  <p:sldSz cx="6858000" cy="9144000" type="screen4x3"/>
  <p:notesSz cx="7099300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3300"/>
    <a:srgbClr val="CC9900"/>
    <a:srgbClr val="FFFF00"/>
    <a:srgbClr val="FF9900"/>
    <a:srgbClr val="003300"/>
    <a:srgbClr val="006600"/>
    <a:srgbClr val="339933"/>
    <a:srgbClr val="008000"/>
    <a:srgbClr val="33CC33"/>
    <a:srgbClr val="00CC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206" autoAdjust="0"/>
    <p:restoredTop sz="83250" autoAdjust="0"/>
  </p:normalViewPr>
  <p:slideViewPr>
    <p:cSldViewPr>
      <p:cViewPr>
        <p:scale>
          <a:sx n="75" d="100"/>
          <a:sy n="75" d="100"/>
        </p:scale>
        <p:origin x="-2160" y="-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916E1EB4-D247-4D0A-9F1F-FCEC857ABD0D}" type="datetimeFigureOut">
              <a:rPr lang="zh-CN" altLang="en-US" smtClean="0"/>
              <a:pPr/>
              <a:t>2013/6/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68350"/>
            <a:ext cx="2876550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9930" y="4861441"/>
            <a:ext cx="5679440" cy="4605576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CAC4B6E1-12AC-476B-8B81-F5166FCED6A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60838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C4B6E1-12AC-476B-8B81-F5166FCED6A1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75522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72CB-45E9-4327-A61B-33F89C5A3190}" type="datetimeFigureOut">
              <a:rPr lang="zh-CN" altLang="en-US" smtClean="0"/>
              <a:pPr/>
              <a:t>2013/6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6063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72CB-45E9-4327-A61B-33F89C5A3190}" type="datetimeFigureOut">
              <a:rPr lang="zh-CN" altLang="en-US" smtClean="0"/>
              <a:pPr/>
              <a:t>2013/6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7382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72CB-45E9-4327-A61B-33F89C5A3190}" type="datetimeFigureOut">
              <a:rPr lang="zh-CN" altLang="en-US" smtClean="0"/>
              <a:pPr/>
              <a:t>2013/6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5664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72CB-45E9-4327-A61B-33F89C5A3190}" type="datetimeFigureOut">
              <a:rPr lang="zh-CN" altLang="en-US" smtClean="0"/>
              <a:pPr/>
              <a:t>2013/6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53069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72CB-45E9-4327-A61B-33F89C5A3190}" type="datetimeFigureOut">
              <a:rPr lang="zh-CN" altLang="en-US" smtClean="0"/>
              <a:pPr/>
              <a:t>2013/6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55926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72CB-45E9-4327-A61B-33F89C5A3190}" type="datetimeFigureOut">
              <a:rPr lang="zh-CN" altLang="en-US" smtClean="0"/>
              <a:pPr/>
              <a:t>2013/6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58698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72CB-45E9-4327-A61B-33F89C5A3190}" type="datetimeFigureOut">
              <a:rPr lang="zh-CN" altLang="en-US" smtClean="0"/>
              <a:pPr/>
              <a:t>2013/6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04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72CB-45E9-4327-A61B-33F89C5A3190}" type="datetimeFigureOut">
              <a:rPr lang="zh-CN" altLang="en-US" smtClean="0"/>
              <a:pPr/>
              <a:t>2013/6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49557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72CB-45E9-4327-A61B-33F89C5A3190}" type="datetimeFigureOut">
              <a:rPr lang="zh-CN" altLang="en-US" smtClean="0"/>
              <a:pPr/>
              <a:t>2013/6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063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72CB-45E9-4327-A61B-33F89C5A3190}" type="datetimeFigureOut">
              <a:rPr lang="zh-CN" altLang="en-US" smtClean="0"/>
              <a:pPr/>
              <a:t>2013/6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98268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72CB-45E9-4327-A61B-33F89C5A3190}" type="datetimeFigureOut">
              <a:rPr lang="zh-CN" altLang="en-US" smtClean="0"/>
              <a:pPr/>
              <a:t>2013/6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43899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D472CB-45E9-4327-A61B-33F89C5A3190}" type="datetimeFigureOut">
              <a:rPr lang="zh-CN" altLang="en-US" smtClean="0"/>
              <a:pPr/>
              <a:t>2013/6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86338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13" Type="http://schemas.openxmlformats.org/officeDocument/2006/relationships/image" Target="../media/image10.jpeg"/><Relationship Id="rId18" Type="http://schemas.openxmlformats.org/officeDocument/2006/relationships/image" Target="../media/image15.jpeg"/><Relationship Id="rId3" Type="http://schemas.openxmlformats.org/officeDocument/2006/relationships/image" Target="../media/image1.jpeg"/><Relationship Id="rId21" Type="http://schemas.openxmlformats.org/officeDocument/2006/relationships/image" Target="../media/image18.jpeg"/><Relationship Id="rId7" Type="http://schemas.openxmlformats.org/officeDocument/2006/relationships/image" Target="../media/image4.jpeg"/><Relationship Id="rId12" Type="http://schemas.openxmlformats.org/officeDocument/2006/relationships/image" Target="../media/image9.jpeg"/><Relationship Id="rId17" Type="http://schemas.openxmlformats.org/officeDocument/2006/relationships/image" Target="../media/image14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3.jpeg"/><Relationship Id="rId20" Type="http://schemas.openxmlformats.org/officeDocument/2006/relationships/image" Target="../media/image1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11" Type="http://schemas.openxmlformats.org/officeDocument/2006/relationships/image" Target="../media/image8.jpeg"/><Relationship Id="rId24" Type="http://schemas.openxmlformats.org/officeDocument/2006/relationships/image" Target="../media/image20.jpeg"/><Relationship Id="rId5" Type="http://schemas.openxmlformats.org/officeDocument/2006/relationships/image" Target="../media/image2.jpeg"/><Relationship Id="rId15" Type="http://schemas.openxmlformats.org/officeDocument/2006/relationships/image" Target="../media/image12.jpeg"/><Relationship Id="rId23" Type="http://schemas.microsoft.com/office/2007/relationships/hdphoto" Target="../media/hdphoto2.wdp"/><Relationship Id="rId10" Type="http://schemas.openxmlformats.org/officeDocument/2006/relationships/image" Target="../media/image7.jpeg"/><Relationship Id="rId19" Type="http://schemas.openxmlformats.org/officeDocument/2006/relationships/image" Target="../media/image16.jpeg"/><Relationship Id="rId4" Type="http://schemas.microsoft.com/office/2007/relationships/hdphoto" Target="../media/hdphoto1.wdp"/><Relationship Id="rId9" Type="http://schemas.openxmlformats.org/officeDocument/2006/relationships/image" Target="../media/image6.jpeg"/><Relationship Id="rId14" Type="http://schemas.openxmlformats.org/officeDocument/2006/relationships/image" Target="../media/image11.jpeg"/><Relationship Id="rId22" Type="http://schemas.openxmlformats.org/officeDocument/2006/relationships/image" Target="../media/image1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李素贞\定位结果\20120913\AVG_849-4 20x.jpg"/>
          <p:cNvPicPr>
            <a:picLocks noChangeAspect="1" noChangeArrowheads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77009" y="4243519"/>
            <a:ext cx="1004400" cy="10044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Picture 2" descr="E:\李素贞\定位结果\kepan\STD_506-1.jp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1102677" y="2131867"/>
            <a:ext cx="1004400" cy="10044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E:\李素贞\定位结果\kepan\506-1-2.jpg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2156949" y="2141392"/>
            <a:ext cx="1004400" cy="10044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" name="直接连接符 4"/>
          <p:cNvCxnSpPr/>
          <p:nvPr/>
        </p:nvCxnSpPr>
        <p:spPr>
          <a:xfrm>
            <a:off x="2855138" y="3077496"/>
            <a:ext cx="25932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/>
          <p:cNvCxnSpPr/>
          <p:nvPr/>
        </p:nvCxnSpPr>
        <p:spPr>
          <a:xfrm>
            <a:off x="1804939" y="3055896"/>
            <a:ext cx="259326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8" name="Picture 4" descr="E:\李素贞\定位结果\kepan\2012.9.7\STD_ad-2.jpg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1376" y="5255517"/>
            <a:ext cx="1004400" cy="10044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E:\李素贞\定位结果\kepan\2012.9.7\ad-2-2.jpg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3083" y="5256880"/>
            <a:ext cx="1004400" cy="10044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9" name="直接连接符 8"/>
          <p:cNvCxnSpPr/>
          <p:nvPr/>
        </p:nvCxnSpPr>
        <p:spPr>
          <a:xfrm>
            <a:off x="2868571" y="6187951"/>
            <a:ext cx="23512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>
            <a:off x="1797436" y="6188511"/>
            <a:ext cx="23512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0" name="Picture 6" descr="E:\李素贞\定位结果\20120913\849-420x.jpg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9094" y="4243519"/>
            <a:ext cx="1004400" cy="10044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 descr="E:\李素贞\定位结果\20120210\STD_gfp-5.jpg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6591" y="1095208"/>
            <a:ext cx="1004400" cy="10044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E:\李素贞\定位结果\20120210\gfp-5-2.jpg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6543" y="1100904"/>
            <a:ext cx="1004400" cy="10044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4" name="直接连接符 13"/>
          <p:cNvCxnSpPr/>
          <p:nvPr/>
        </p:nvCxnSpPr>
        <p:spPr>
          <a:xfrm>
            <a:off x="1868493" y="2043659"/>
            <a:ext cx="17288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>
            <a:off x="2934047" y="2036364"/>
            <a:ext cx="17288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3" name="Picture 9" descr="E:\李素贞\定位结果\20120210\LSZ\STD_11-16-6-B.jpg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4073649" y="1101977"/>
            <a:ext cx="1004400" cy="10044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E:\李素贞\定位结果\20120210\LSZ\11-16-6-B-2.jpg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5125356" y="1101977"/>
            <a:ext cx="1004400" cy="10044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8" name="直接连接符 17"/>
          <p:cNvCxnSpPr/>
          <p:nvPr/>
        </p:nvCxnSpPr>
        <p:spPr>
          <a:xfrm>
            <a:off x="4683405" y="2044135"/>
            <a:ext cx="34231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连接符 18"/>
          <p:cNvCxnSpPr/>
          <p:nvPr/>
        </p:nvCxnSpPr>
        <p:spPr>
          <a:xfrm>
            <a:off x="5733656" y="2049545"/>
            <a:ext cx="3423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5" name="Picture 11" descr="E:\李素贞\定位结果\20120208\LSZ\STD_11-16-3-a.jpg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73649" y="3202471"/>
            <a:ext cx="1004400" cy="10044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6" name="Picture 12" descr="E:\李素贞\定位结果\20120208\LSZ\11-16-3-a-2.jpg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5356" y="3202471"/>
            <a:ext cx="1004400" cy="10044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2" name="直接连接符 21"/>
          <p:cNvCxnSpPr/>
          <p:nvPr/>
        </p:nvCxnSpPr>
        <p:spPr>
          <a:xfrm>
            <a:off x="5914336" y="4152698"/>
            <a:ext cx="16251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>
            <a:off x="4861569" y="4148594"/>
            <a:ext cx="162511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/>
          <p:cNvCxnSpPr/>
          <p:nvPr/>
        </p:nvCxnSpPr>
        <p:spPr>
          <a:xfrm>
            <a:off x="5867657" y="5194109"/>
            <a:ext cx="20054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连接符 24"/>
          <p:cNvCxnSpPr/>
          <p:nvPr/>
        </p:nvCxnSpPr>
        <p:spPr>
          <a:xfrm>
            <a:off x="4805532" y="5177099"/>
            <a:ext cx="200545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7" name="Picture 13" descr="E:\李素贞\定位结果\2012.9.20\STD_282-3.jpg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4790" y="3166840"/>
            <a:ext cx="1004400" cy="10044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8" name="Picture 14" descr="E:\李素贞\定位结果\2012.9.20\282-3-2.jpg"/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9352" y="3166840"/>
            <a:ext cx="1004400" cy="10044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8" name="直接连接符 27"/>
          <p:cNvCxnSpPr/>
          <p:nvPr/>
        </p:nvCxnSpPr>
        <p:spPr>
          <a:xfrm>
            <a:off x="2809153" y="4113321"/>
            <a:ext cx="29390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连接符 28"/>
          <p:cNvCxnSpPr/>
          <p:nvPr/>
        </p:nvCxnSpPr>
        <p:spPr>
          <a:xfrm>
            <a:off x="1719610" y="4103977"/>
            <a:ext cx="29390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9" name="Picture 15" descr="E:\李素贞\定位结果\2012.9.19\STD_249-4.jpg"/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4079681" y="2152912"/>
            <a:ext cx="1004400" cy="10044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0" name="Picture 16" descr="E:\李素贞\定位结果\2012.9.19\249-4-2.jpg"/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5138237" y="2152912"/>
            <a:ext cx="1004400" cy="10044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2" name="直接连接符 31"/>
          <p:cNvCxnSpPr/>
          <p:nvPr/>
        </p:nvCxnSpPr>
        <p:spPr>
          <a:xfrm>
            <a:off x="5833715" y="3102659"/>
            <a:ext cx="25932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>
            <a:off x="4763481" y="3102734"/>
            <a:ext cx="259326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41" name="Picture 17" descr="E:\李素贞\定位结果\2012.9.19\STD_628-3.jpg"/>
          <p:cNvPicPr>
            <a:picLocks noChangeAspect="1"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6257" y="4212044"/>
            <a:ext cx="1004400" cy="1004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2" name="Picture 18" descr="E:\李素贞\定位结果\2012.9.19\628-3-2.jpg"/>
          <p:cNvPicPr>
            <a:picLocks noChangeAspect="1"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2557" y="4212044"/>
            <a:ext cx="1004400" cy="10044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6" name="直接连接符 35"/>
          <p:cNvCxnSpPr/>
          <p:nvPr/>
        </p:nvCxnSpPr>
        <p:spPr>
          <a:xfrm>
            <a:off x="2775314" y="5164519"/>
            <a:ext cx="32847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/>
          <p:cNvCxnSpPr/>
          <p:nvPr/>
        </p:nvCxnSpPr>
        <p:spPr>
          <a:xfrm>
            <a:off x="1722515" y="5153699"/>
            <a:ext cx="328479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43" name="Picture 19" descr="E:\李素贞\定位结果\20120208\LSZ\STD_11-16-6-b.jpg"/>
          <p:cNvPicPr>
            <a:picLocks noChangeAspect="1" noChangeArrowheads="1"/>
          </p:cNvPicPr>
          <p:nvPr/>
        </p:nvPicPr>
        <p:blipFill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78921" y="5282352"/>
            <a:ext cx="1004400" cy="10044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4" name="Picture 20" descr="E:\李素贞\定位结果\20120208\LSZ\11-16-6-b-2.jpg"/>
          <p:cNvPicPr>
            <a:picLocks noChangeAspect="1" noChangeArrowheads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4096" y="5282352"/>
            <a:ext cx="1004400" cy="10044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40" name="直接连接符 39"/>
          <p:cNvCxnSpPr/>
          <p:nvPr/>
        </p:nvCxnSpPr>
        <p:spPr>
          <a:xfrm>
            <a:off x="4880059" y="6190395"/>
            <a:ext cx="13139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连接符 40"/>
          <p:cNvCxnSpPr/>
          <p:nvPr/>
        </p:nvCxnSpPr>
        <p:spPr>
          <a:xfrm>
            <a:off x="5922752" y="6199739"/>
            <a:ext cx="1313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1059127" y="781507"/>
            <a:ext cx="967195" cy="2364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Fluorescence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177279" y="786831"/>
            <a:ext cx="827088" cy="2364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Bright field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4063310" y="789869"/>
            <a:ext cx="967195" cy="2364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Fluorescence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5210734" y="795193"/>
            <a:ext cx="827088" cy="2364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Bright field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624488" y="1211544"/>
            <a:ext cx="429864" cy="50253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endParaRPr lang="en-US" altLang="zh-CN" b="1" dirty="0" smtClean="0">
              <a:latin typeface="Arial" pitchFamily="34" charset="0"/>
              <a:cs typeface="Arial" pitchFamily="34" charset="0"/>
            </a:endParaRPr>
          </a:p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GFP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421258" y="2496987"/>
            <a:ext cx="703433" cy="2679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ZmZIP1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11797" y="3549780"/>
            <a:ext cx="703433" cy="2679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ZmZIP2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421258" y="4639779"/>
            <a:ext cx="703433" cy="2679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ZmZIP3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411797" y="5685094"/>
            <a:ext cx="703433" cy="2679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ZmZIP4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3425479" y="1492308"/>
            <a:ext cx="703435" cy="2679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ZmZIP5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3432353" y="3590897"/>
            <a:ext cx="703435" cy="2679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ZmZIP7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3432352" y="4647227"/>
            <a:ext cx="703435" cy="2679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ZmZIP8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3442534" y="5700116"/>
            <a:ext cx="65434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ZmIRT1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3429987" y="2500382"/>
            <a:ext cx="703435" cy="2679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ZmZIP6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1078583" y="1095209"/>
            <a:ext cx="2085169" cy="5166072"/>
          </a:xfrm>
          <a:prstGeom prst="rect">
            <a:avLst/>
          </a:prstGeom>
          <a:noFill/>
          <a:ln w="381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7" name="直接连接符 6"/>
          <p:cNvCxnSpPr/>
          <p:nvPr/>
        </p:nvCxnSpPr>
        <p:spPr>
          <a:xfrm>
            <a:off x="2130895" y="1101977"/>
            <a:ext cx="1" cy="5159304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矩形 60"/>
          <p:cNvSpPr/>
          <p:nvPr/>
        </p:nvSpPr>
        <p:spPr>
          <a:xfrm>
            <a:off x="4060679" y="1101976"/>
            <a:ext cx="2085169" cy="5166072"/>
          </a:xfrm>
          <a:prstGeom prst="rect">
            <a:avLst/>
          </a:prstGeom>
          <a:noFill/>
          <a:ln w="381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3" name="直接连接符 12"/>
          <p:cNvCxnSpPr/>
          <p:nvPr/>
        </p:nvCxnSpPr>
        <p:spPr>
          <a:xfrm>
            <a:off x="1063765" y="2116105"/>
            <a:ext cx="2088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接连接符 63"/>
          <p:cNvCxnSpPr/>
          <p:nvPr/>
        </p:nvCxnSpPr>
        <p:spPr>
          <a:xfrm>
            <a:off x="1089701" y="3155208"/>
            <a:ext cx="2088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接连接符 64"/>
          <p:cNvCxnSpPr/>
          <p:nvPr/>
        </p:nvCxnSpPr>
        <p:spPr>
          <a:xfrm>
            <a:off x="1066997" y="4192504"/>
            <a:ext cx="2088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接连接符 65"/>
          <p:cNvCxnSpPr/>
          <p:nvPr/>
        </p:nvCxnSpPr>
        <p:spPr>
          <a:xfrm>
            <a:off x="1063749" y="5233712"/>
            <a:ext cx="2088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接连接符 66"/>
          <p:cNvCxnSpPr/>
          <p:nvPr/>
        </p:nvCxnSpPr>
        <p:spPr>
          <a:xfrm>
            <a:off x="5102954" y="1108457"/>
            <a:ext cx="1" cy="5159304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连接符 67"/>
          <p:cNvCxnSpPr/>
          <p:nvPr/>
        </p:nvCxnSpPr>
        <p:spPr>
          <a:xfrm>
            <a:off x="4045552" y="2132313"/>
            <a:ext cx="2088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连接符 68"/>
          <p:cNvCxnSpPr/>
          <p:nvPr/>
        </p:nvCxnSpPr>
        <p:spPr>
          <a:xfrm>
            <a:off x="4071488" y="3181144"/>
            <a:ext cx="2088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接连接符 69"/>
          <p:cNvCxnSpPr/>
          <p:nvPr/>
        </p:nvCxnSpPr>
        <p:spPr>
          <a:xfrm>
            <a:off x="4048784" y="4218440"/>
            <a:ext cx="2088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接连接符 70"/>
          <p:cNvCxnSpPr/>
          <p:nvPr/>
        </p:nvCxnSpPr>
        <p:spPr>
          <a:xfrm>
            <a:off x="4045536" y="5259648"/>
            <a:ext cx="2088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217235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65</TotalTime>
  <Words>17</Words>
  <Application>Microsoft Office PowerPoint</Application>
  <PresentationFormat>全屏显示(4:3)</PresentationFormat>
  <Paragraphs>16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user</dc:creator>
  <cp:lastModifiedBy>user</cp:lastModifiedBy>
  <cp:revision>248</cp:revision>
  <cp:lastPrinted>2013-05-31T08:43:37Z</cp:lastPrinted>
  <dcterms:created xsi:type="dcterms:W3CDTF">2012-11-13T14:49:13Z</dcterms:created>
  <dcterms:modified xsi:type="dcterms:W3CDTF">2013-06-02T08:16:41Z</dcterms:modified>
</cp:coreProperties>
</file>